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6" d="100"/>
          <a:sy n="156" d="100"/>
        </p:scale>
        <p:origin x="-168" y="3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929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187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271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213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874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670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761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704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173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827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274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3D040-092E-7148-AB4F-472BF36F3303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03790-DC1C-9D4C-BCC3-73443540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93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Relationship Id="rId3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6944" y="1200146"/>
            <a:ext cx="4046268" cy="488375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34466" y="897770"/>
            <a:ext cx="3573024" cy="518612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96513" y="155980"/>
            <a:ext cx="49549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 smtClean="0"/>
              <a:t>A</a:t>
            </a:r>
            <a:endParaRPr lang="en-US" sz="4000" b="1" dirty="0"/>
          </a:p>
        </p:txBody>
      </p:sp>
      <p:sp>
        <p:nvSpPr>
          <p:cNvPr id="7" name="Rectangle 6"/>
          <p:cNvSpPr/>
          <p:nvPr/>
        </p:nvSpPr>
        <p:spPr>
          <a:xfrm>
            <a:off x="844619" y="1406468"/>
            <a:ext cx="3371149" cy="2467952"/>
          </a:xfrm>
          <a:prstGeom prst="rect">
            <a:avLst/>
          </a:prstGeom>
          <a:noFill/>
          <a:ln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651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6513" y="155980"/>
            <a:ext cx="47220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B</a:t>
            </a:r>
            <a:endParaRPr lang="en-US" sz="40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76122" y="3686731"/>
            <a:ext cx="2799978" cy="214138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89791" y="703862"/>
            <a:ext cx="3612879" cy="5198791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624099" y="3796491"/>
            <a:ext cx="704983" cy="1919936"/>
          </a:xfrm>
          <a:prstGeom prst="rect">
            <a:avLst/>
          </a:prstGeom>
          <a:noFill/>
          <a:ln w="19050" cmpd="sng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5813410" y="3796491"/>
            <a:ext cx="704983" cy="1919936"/>
          </a:xfrm>
          <a:prstGeom prst="rect">
            <a:avLst/>
          </a:prstGeom>
          <a:noFill/>
          <a:ln w="19050" cmpd="sng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0089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6513" y="155980"/>
            <a:ext cx="45617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 smtClean="0"/>
              <a:t>C</a:t>
            </a:r>
            <a:endParaRPr lang="en-US" sz="40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1982" y="722811"/>
            <a:ext cx="4660036" cy="54123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82574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6513" y="155980"/>
            <a:ext cx="50802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D</a:t>
            </a:r>
            <a:endParaRPr lang="en-US" sz="40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3406" y="1692492"/>
            <a:ext cx="5743956" cy="146913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4402309" y="1506104"/>
            <a:ext cx="7181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sz="1200" i="1" dirty="0"/>
              <a:t>a</a:t>
            </a:r>
            <a:r>
              <a:rPr lang="en-US" sz="1200" i="1" dirty="0" smtClean="0"/>
              <a:t>rf8-4</a:t>
            </a:r>
            <a:r>
              <a:rPr lang="en-US" sz="1200" dirty="0" smtClean="0"/>
              <a:t> </a:t>
            </a:r>
            <a:r>
              <a:rPr lang="en-US" sz="1200" baseline="30000" dirty="0" smtClean="0"/>
              <a:t>-/-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5576846" y="1559019"/>
            <a:ext cx="625147" cy="2333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100" dirty="0" smtClean="0"/>
              <a:t>P6 (</a:t>
            </a:r>
            <a:r>
              <a:rPr lang="en-US" sz="1100" dirty="0" err="1" smtClean="0"/>
              <a:t>Ler</a:t>
            </a:r>
            <a:r>
              <a:rPr lang="en-US" sz="1100" dirty="0" smtClean="0"/>
              <a:t>)</a:t>
            </a:r>
            <a:endParaRPr lang="en-US" sz="1100" dirty="0"/>
          </a:p>
        </p:txBody>
      </p:sp>
      <p:sp>
        <p:nvSpPr>
          <p:cNvPr id="8" name="Rectangle 7"/>
          <p:cNvSpPr/>
          <p:nvPr/>
        </p:nvSpPr>
        <p:spPr>
          <a:xfrm rot="16200000">
            <a:off x="2467784" y="1180082"/>
            <a:ext cx="1397126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70000"/>
              </a:lnSpc>
            </a:pPr>
            <a:r>
              <a:rPr lang="en-US" sz="1100" i="1" dirty="0" smtClean="0"/>
              <a:t>arf8-4</a:t>
            </a:r>
            <a:r>
              <a:rPr lang="en-US" sz="1100" dirty="0" smtClean="0"/>
              <a:t> </a:t>
            </a:r>
            <a:r>
              <a:rPr lang="en-US" sz="1100" baseline="30000" dirty="0" smtClean="0"/>
              <a:t>+/-</a:t>
            </a:r>
            <a:r>
              <a:rPr lang="en-US" sz="1100" dirty="0" smtClean="0"/>
              <a:t> x P6(</a:t>
            </a:r>
            <a:r>
              <a:rPr lang="en-US" sz="1100" dirty="0" err="1" smtClean="0"/>
              <a:t>Ler</a:t>
            </a:r>
            <a:r>
              <a:rPr lang="en-US" sz="1100" dirty="0" smtClean="0"/>
              <a:t>) F1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9337474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6513" y="155980"/>
            <a:ext cx="43488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 smtClean="0"/>
              <a:t>E</a:t>
            </a:r>
            <a:endParaRPr lang="en-US" sz="4000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11859" y="2464615"/>
            <a:ext cx="3495936" cy="279218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40711" y="2756335"/>
            <a:ext cx="3405191" cy="2184908"/>
          </a:xfrm>
          <a:prstGeom prst="rect">
            <a:avLst/>
          </a:prstGeom>
        </p:spPr>
      </p:pic>
      <p:grpSp>
        <p:nvGrpSpPr>
          <p:cNvPr id="31" name="Group 30"/>
          <p:cNvGrpSpPr/>
          <p:nvPr/>
        </p:nvGrpSpPr>
        <p:grpSpPr>
          <a:xfrm>
            <a:off x="1597783" y="1250879"/>
            <a:ext cx="1837387" cy="1560024"/>
            <a:chOff x="1597783" y="1245664"/>
            <a:chExt cx="1837387" cy="1560024"/>
          </a:xfrm>
        </p:grpSpPr>
        <p:sp>
          <p:nvSpPr>
            <p:cNvPr id="8" name="TextBox 7"/>
            <p:cNvSpPr txBox="1"/>
            <p:nvPr/>
          </p:nvSpPr>
          <p:spPr>
            <a:xfrm rot="16200000">
              <a:off x="1228215" y="2174510"/>
              <a:ext cx="10007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(Turnip)</a:t>
              </a:r>
              <a:endParaRPr lang="en-US" sz="1100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1830341" y="2511952"/>
              <a:ext cx="2796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/>
                <a:t>ø</a:t>
              </a:r>
              <a:endParaRPr lang="en-US" sz="1400" dirty="0" smtClean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1753017" y="2216113"/>
              <a:ext cx="9175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Mock (Col-0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1689853" y="1934433"/>
              <a:ext cx="14809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sample 1 (Col-0) 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1908369" y="1934433"/>
              <a:ext cx="14809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sample 2 (Col-0)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2383869" y="2191417"/>
              <a:ext cx="9669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Mock (</a:t>
              </a:r>
              <a:r>
                <a:rPr lang="en-US" sz="1100" i="1" dirty="0" smtClean="0"/>
                <a:t>arf8-6</a:t>
              </a:r>
              <a:r>
                <a:rPr lang="en-US" sz="1100" dirty="0" smtClean="0"/>
                <a:t>)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2305839" y="1894871"/>
              <a:ext cx="15600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sample 1 (</a:t>
              </a:r>
              <a:r>
                <a:rPr lang="en-US" sz="1100" i="1" dirty="0" smtClean="0"/>
                <a:t>arf8-6</a:t>
              </a:r>
              <a:r>
                <a:rPr lang="en-US" sz="1100" dirty="0" smtClean="0"/>
                <a:t>)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2537189" y="1907707"/>
              <a:ext cx="15343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sample 2 (</a:t>
              </a:r>
              <a:r>
                <a:rPr lang="en-US" sz="1100" i="1" dirty="0" smtClean="0"/>
                <a:t>arf8-6</a:t>
              </a:r>
              <a:r>
                <a:rPr lang="en-US" sz="1100" dirty="0" smtClean="0"/>
                <a:t>)</a:t>
              </a:r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5527455" y="1250879"/>
            <a:ext cx="1837387" cy="1560024"/>
            <a:chOff x="1597783" y="1245664"/>
            <a:chExt cx="1837387" cy="1560024"/>
          </a:xfrm>
        </p:grpSpPr>
        <p:sp>
          <p:nvSpPr>
            <p:cNvPr id="41" name="TextBox 40"/>
            <p:cNvSpPr txBox="1"/>
            <p:nvPr/>
          </p:nvSpPr>
          <p:spPr>
            <a:xfrm rot="16200000">
              <a:off x="1228215" y="2174510"/>
              <a:ext cx="10007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(Turnip)</a:t>
              </a:r>
              <a:endParaRPr lang="en-US" sz="1100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1830341" y="2511952"/>
              <a:ext cx="2796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/>
                <a:t>ø</a:t>
              </a:r>
              <a:endParaRPr lang="en-US" sz="1400" dirty="0" smtClean="0"/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1753017" y="2216113"/>
              <a:ext cx="9175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Mock (Col-0)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1689853" y="1934433"/>
              <a:ext cx="14809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sample 1 (Col-0) 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1908369" y="1934433"/>
              <a:ext cx="14809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sample 2 (Col-0)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2383869" y="2191417"/>
              <a:ext cx="9669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Mock (</a:t>
              </a:r>
              <a:r>
                <a:rPr lang="en-US" sz="1100" i="1" dirty="0" smtClean="0"/>
                <a:t>arf8-6</a:t>
              </a:r>
              <a:r>
                <a:rPr lang="en-US" sz="1100" dirty="0" smtClean="0"/>
                <a:t>)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2305839" y="1894871"/>
              <a:ext cx="15600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sample 1 (</a:t>
              </a:r>
              <a:r>
                <a:rPr lang="en-US" sz="1100" i="1" dirty="0" smtClean="0"/>
                <a:t>arf8-6</a:t>
              </a:r>
              <a:r>
                <a:rPr lang="en-US" sz="1100" dirty="0" smtClean="0"/>
                <a:t>)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 rot="16200000">
              <a:off x="2537189" y="1907707"/>
              <a:ext cx="15343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/>
                <a:t>TuMV</a:t>
              </a:r>
              <a:r>
                <a:rPr lang="en-US" sz="1100" dirty="0" smtClean="0"/>
                <a:t> sample 2 (</a:t>
              </a:r>
              <a:r>
                <a:rPr lang="en-US" sz="1100" i="1" dirty="0" smtClean="0"/>
                <a:t>arf8-6</a:t>
              </a:r>
              <a:r>
                <a:rPr lang="en-US" sz="1100" dirty="0" smtClean="0"/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19837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25</Words>
  <Application>Microsoft Macintosh PowerPoint</Application>
  <PresentationFormat>On-screen Show (4:3)</PresentationFormat>
  <Paragraphs>24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o lof</dc:creator>
  <cp:lastModifiedBy>flo lof</cp:lastModifiedBy>
  <cp:revision>6</cp:revision>
  <dcterms:created xsi:type="dcterms:W3CDTF">2016-01-15T16:57:33Z</dcterms:created>
  <dcterms:modified xsi:type="dcterms:W3CDTF">2016-01-15T17:31:10Z</dcterms:modified>
</cp:coreProperties>
</file>